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68"/>
  </p:normalViewPr>
  <p:slideViewPr>
    <p:cSldViewPr snapToGrid="0">
      <p:cViewPr varScale="1">
        <p:scale>
          <a:sx n="92" d="100"/>
          <a:sy n="92" d="100"/>
        </p:scale>
        <p:origin x="7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qj9\OneDrive%20-%20CDC\Indonesia%20projects\2017%20carriage\Analysis\2017%20pneumo%20analysis%20tables%20figure%2018May202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Bar chart carriage rate'!$C$4</c:f>
              <c:strCache>
                <c:ptCount val="1"/>
                <c:pt idx="0">
                  <c:v>Overall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'Bar chart carriage rate'!$B$5:$B$8</c:f>
              <c:strCache>
                <c:ptCount val="4"/>
                <c:pt idx="0">
                  <c:v>&lt;1 year</c:v>
                </c:pt>
                <c:pt idx="1">
                  <c:v>1-2 years</c:v>
                </c:pt>
                <c:pt idx="2">
                  <c:v>3-4 years</c:v>
                </c:pt>
                <c:pt idx="3">
                  <c:v>All ages</c:v>
                </c:pt>
              </c:strCache>
            </c:strRef>
          </c:cat>
          <c:val>
            <c:numRef>
              <c:f>'Bar chart carriage rate'!$C$5:$C$8</c:f>
              <c:numCache>
                <c:formatCode>0.00%</c:formatCode>
                <c:ptCount val="4"/>
                <c:pt idx="0">
                  <c:v>0.503</c:v>
                </c:pt>
                <c:pt idx="1">
                  <c:v>0.61399999999999999</c:v>
                </c:pt>
                <c:pt idx="2">
                  <c:v>0.54200000000000004</c:v>
                </c:pt>
                <c:pt idx="3">
                  <c:v>0.562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21-6144-B387-43B39CA0E9AD}"/>
            </c:ext>
          </c:extLst>
        </c:ser>
        <c:ser>
          <c:idx val="1"/>
          <c:order val="1"/>
          <c:tx>
            <c:strRef>
              <c:f>'Bar chart carriage rate'!$D$4</c:f>
              <c:strCache>
                <c:ptCount val="1"/>
                <c:pt idx="0">
                  <c:v>Southwest Sumba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cat>
            <c:strRef>
              <c:f>'Bar chart carriage rate'!$B$5:$B$8</c:f>
              <c:strCache>
                <c:ptCount val="4"/>
                <c:pt idx="0">
                  <c:v>&lt;1 year</c:v>
                </c:pt>
                <c:pt idx="1">
                  <c:v>1-2 years</c:v>
                </c:pt>
                <c:pt idx="2">
                  <c:v>3-4 years</c:v>
                </c:pt>
                <c:pt idx="3">
                  <c:v>All ages</c:v>
                </c:pt>
              </c:strCache>
            </c:strRef>
          </c:cat>
          <c:val>
            <c:numRef>
              <c:f>'Bar chart carriage rate'!$D$5:$D$8</c:f>
              <c:numCache>
                <c:formatCode>0.00%</c:formatCode>
                <c:ptCount val="4"/>
                <c:pt idx="0">
                  <c:v>0.85</c:v>
                </c:pt>
                <c:pt idx="1">
                  <c:v>0.89800000000000002</c:v>
                </c:pt>
                <c:pt idx="2">
                  <c:v>0.86699999999999999</c:v>
                </c:pt>
                <c:pt idx="3">
                  <c:v>0.8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421-6144-B387-43B39CA0E9AD}"/>
            </c:ext>
          </c:extLst>
        </c:ser>
        <c:ser>
          <c:idx val="2"/>
          <c:order val="2"/>
          <c:tx>
            <c:strRef>
              <c:f>'Bar chart carriage rate'!$E$4</c:f>
              <c:strCache>
                <c:ptCount val="1"/>
                <c:pt idx="0">
                  <c:v>Gunungkidul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Bar chart carriage rate'!$B$5:$B$8</c:f>
              <c:strCache>
                <c:ptCount val="4"/>
                <c:pt idx="0">
                  <c:v>&lt;1 year</c:v>
                </c:pt>
                <c:pt idx="1">
                  <c:v>1-2 years</c:v>
                </c:pt>
                <c:pt idx="2">
                  <c:v>3-4 years</c:v>
                </c:pt>
                <c:pt idx="3">
                  <c:v>All ages</c:v>
                </c:pt>
              </c:strCache>
            </c:strRef>
          </c:cat>
          <c:val>
            <c:numRef>
              <c:f>'Bar chart carriage rate'!$E$5:$E$8</c:f>
              <c:numCache>
                <c:formatCode>0.0%</c:formatCode>
                <c:ptCount val="4"/>
                <c:pt idx="0">
                  <c:v>0.21</c:v>
                </c:pt>
                <c:pt idx="1">
                  <c:v>0.35899999999999999</c:v>
                </c:pt>
                <c:pt idx="2">
                  <c:v>0.32</c:v>
                </c:pt>
                <c:pt idx="3" formatCode="0.00%">
                  <c:v>0.3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421-6144-B387-43B39CA0E9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588097456"/>
        <c:axId val="-1588095136"/>
      </c:barChart>
      <c:catAx>
        <c:axId val="-1588097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88095136"/>
        <c:crosses val="autoZero"/>
        <c:auto val="1"/>
        <c:lblAlgn val="ctr"/>
        <c:lblOffset val="100"/>
        <c:noMultiLvlLbl val="0"/>
      </c:catAx>
      <c:valAx>
        <c:axId val="-15880951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neumococcal Carriage Prevalenc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880974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Bar chart carriage rate'!$C$27</c:f>
              <c:strCache>
                <c:ptCount val="1"/>
                <c:pt idx="0">
                  <c:v>Overall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'Bar chart carriage rate'!$B$28:$B$31</c:f>
              <c:strCache>
                <c:ptCount val="4"/>
                <c:pt idx="0">
                  <c:v>&lt;1 year</c:v>
                </c:pt>
                <c:pt idx="1">
                  <c:v>1-2 years</c:v>
                </c:pt>
                <c:pt idx="2">
                  <c:v>3-4 years</c:v>
                </c:pt>
                <c:pt idx="3">
                  <c:v>All ages</c:v>
                </c:pt>
              </c:strCache>
            </c:strRef>
          </c:cat>
          <c:val>
            <c:numRef>
              <c:f>'Bar chart carriage rate'!$C$28:$C$31</c:f>
              <c:numCache>
                <c:formatCode>0.00%</c:formatCode>
                <c:ptCount val="4"/>
                <c:pt idx="0">
                  <c:v>0.26500000000000001</c:v>
                </c:pt>
                <c:pt idx="1">
                  <c:v>0.371</c:v>
                </c:pt>
                <c:pt idx="2">
                  <c:v>0.29099999999999998</c:v>
                </c:pt>
                <c:pt idx="3">
                  <c:v>0.3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ED-8C44-B002-47FE18C7E88A}"/>
            </c:ext>
          </c:extLst>
        </c:ser>
        <c:ser>
          <c:idx val="1"/>
          <c:order val="1"/>
          <c:tx>
            <c:strRef>
              <c:f>'Bar chart carriage rate'!$D$27</c:f>
              <c:strCache>
                <c:ptCount val="1"/>
                <c:pt idx="0">
                  <c:v>Southwest Sumba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cat>
            <c:strRef>
              <c:f>'Bar chart carriage rate'!$B$28:$B$31</c:f>
              <c:strCache>
                <c:ptCount val="4"/>
                <c:pt idx="0">
                  <c:v>&lt;1 year</c:v>
                </c:pt>
                <c:pt idx="1">
                  <c:v>1-2 years</c:v>
                </c:pt>
                <c:pt idx="2">
                  <c:v>3-4 years</c:v>
                </c:pt>
                <c:pt idx="3">
                  <c:v>All ages</c:v>
                </c:pt>
              </c:strCache>
            </c:strRef>
          </c:cat>
          <c:val>
            <c:numRef>
              <c:f>'Bar chart carriage rate'!$D$28:$D$31</c:f>
              <c:numCache>
                <c:formatCode>0.0%</c:formatCode>
                <c:ptCount val="4"/>
                <c:pt idx="0">
                  <c:v>0.46100000000000002</c:v>
                </c:pt>
                <c:pt idx="1">
                  <c:v>0.60899999999999999</c:v>
                </c:pt>
                <c:pt idx="2">
                  <c:v>0.46</c:v>
                </c:pt>
                <c:pt idx="3">
                  <c:v>0.526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4ED-8C44-B002-47FE18C7E88A}"/>
            </c:ext>
          </c:extLst>
        </c:ser>
        <c:ser>
          <c:idx val="2"/>
          <c:order val="2"/>
          <c:tx>
            <c:strRef>
              <c:f>'Bar chart carriage rate'!$E$27</c:f>
              <c:strCache>
                <c:ptCount val="1"/>
                <c:pt idx="0">
                  <c:v>Gunungkidul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Bar chart carriage rate'!$B$28:$B$31</c:f>
              <c:strCache>
                <c:ptCount val="4"/>
                <c:pt idx="0">
                  <c:v>&lt;1 year</c:v>
                </c:pt>
                <c:pt idx="1">
                  <c:v>1-2 years</c:v>
                </c:pt>
                <c:pt idx="2">
                  <c:v>3-4 years</c:v>
                </c:pt>
                <c:pt idx="3">
                  <c:v>All ages</c:v>
                </c:pt>
              </c:strCache>
            </c:strRef>
          </c:cat>
          <c:val>
            <c:numRef>
              <c:f>'Bar chart carriage rate'!$E$28:$E$31</c:f>
              <c:numCache>
                <c:formatCode>0.0%</c:formatCode>
                <c:ptCount val="4"/>
                <c:pt idx="0">
                  <c:v>9.8699999999999996E-2</c:v>
                </c:pt>
                <c:pt idx="1">
                  <c:v>0.15709999999999999</c:v>
                </c:pt>
                <c:pt idx="2">
                  <c:v>0.17599999999999999</c:v>
                </c:pt>
                <c:pt idx="3">
                  <c:v>0.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4ED-8C44-B002-47FE18C7E8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588067760"/>
        <c:axId val="-1588065440"/>
      </c:barChart>
      <c:catAx>
        <c:axId val="-1588067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88065440"/>
        <c:crosses val="autoZero"/>
        <c:auto val="1"/>
        <c:lblAlgn val="ctr"/>
        <c:lblOffset val="100"/>
        <c:noMultiLvlLbl val="0"/>
      </c:catAx>
      <c:valAx>
        <c:axId val="-15880654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Vaccine Serotype Pneumococcal Carriage Prevalenc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880677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CD1760-8046-B220-3462-21985A7750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1E3F23-14E6-6959-0CEE-0FBA1C89B0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803430-37C8-66A2-461A-0C9FCC226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75D2F8-9E8F-BA51-3531-14DF4F474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509B84-3575-26D0-BF93-148EF5AE86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847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29BA9-D313-22D7-FA26-4831DAA819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22F6B1-27F1-7E06-633E-53879C476D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8D2CF7-4B1E-C9A0-C95C-2E0EED3DA5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F375A6-9EB7-CCEC-C368-638B4F707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644E54-68C4-5ABD-8E7B-0A0B3EA8EE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547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E7DA9F-B7B4-5850-1112-E362DAD3D2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A4AF0F-EB40-AE07-1527-B8E0CED877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AB037D-F2BC-42DB-0127-9687EECEE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2F49B3-0188-78EF-E225-B73CB83C2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5EC855-F429-DC0A-9D17-2EB379EE4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910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DEA285-C55E-C1B4-C560-41BDBE419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505F9A-55C2-3AFF-DDAF-424757D06C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4B3D8D-855C-6525-0055-CCA5E39F59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29F98B-0FC4-79D4-FAAF-1AD34C28F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8B4A57-6C0D-B39E-DCC9-5E3807109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215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3FF7CC-7653-2350-906C-F3A7575E12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A421F1-4FCF-508E-A42F-447DE476B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48AD47-1C35-A463-CF91-A2A59322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27AE94-1770-7242-7D6E-C0058FFE0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6CE18E-5D17-2DA8-DD27-682ADA1CC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842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E2C71D-F4B8-8EA8-5AD7-21C8497A9C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E7882F-F2E5-7040-0C04-54A777A111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7E7C1A-CAF5-470C-542E-19374190F6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BFDB8A-553F-2132-2FB1-9966861BD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D8CF6B-0797-0414-53A4-4574E7BD3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9EC9D0-9975-21A6-BD3F-468E070D4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629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5CE58A-6D8C-C8CA-9D10-F27B42CA9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AB473D-527A-F7D4-340D-49D02F68CE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3467A7-AFD7-60FC-CE05-4DDCE3D8D0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E5DF9E-1D53-4D74-CCB7-2B139B9FB6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87744B-7D7B-2B45-DEC7-919F2D9AFA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2F0307-BA75-5E4B-0D8A-7649AA3F6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BA502E-2A08-A74E-4449-111D3A216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475799-8F5A-798F-3EFC-C9862D937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682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8205EE-01DE-2C55-3289-035EC23344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137917-2C28-2E21-A068-0EBF8377A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82DB4C8-851E-2172-8F97-B4F47E0D3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2EB073-CDF9-39D0-5F44-9FF3738C3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499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0331E6-17E2-FE71-FC6D-0837402E7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D458F94-DAE0-A3C1-50CD-178BAB878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603866-99DA-D475-D339-244DC07F9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989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3BC6D9-7754-841C-E20B-4763644BA1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9B28E6-458B-94DB-F0EA-BCCFB53FBC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9A5CC7-4F50-FD2B-CD07-18D13F2968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70721B-058D-8365-0622-A7BA2F90B0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B310FC-E384-B9CF-664F-088516667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B1B272-B585-563D-62BF-37A2435B7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460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AA032-63FB-028E-2AFA-E4C989058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1DECDC0-481A-C4D1-E953-1D443934FD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A36B5E-FE94-6466-AFC7-A841947851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3DF2BC-2C2C-276F-6FD3-331FF0CF4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943253-59C9-FF4F-7D4E-8F37249EA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5A7538-DB15-C172-BB2D-F8B11609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82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97827C-96EA-B109-7212-FB55C8D34B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E05813-D0AB-9D18-B199-14B947EF2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DA4E3-BF3C-FE59-CB89-E2A2457AD0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5E756-944D-5C44-BCBF-253DE3E2A701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4BAA00-F8AC-4CAD-196C-D4F66C9517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D86518-29A3-F499-DA75-68D2DE0A52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FED62-472D-884A-838D-D08A1EBE4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272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04F60E3-BC0C-480B-069B-D57F69F7B4AD}"/>
              </a:ext>
            </a:extLst>
          </p:cNvPr>
          <p:cNvSpPr txBox="1"/>
          <p:nvPr/>
        </p:nvSpPr>
        <p:spPr>
          <a:xfrm>
            <a:off x="329539" y="302361"/>
            <a:ext cx="1161703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ID" sz="18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. Streptococcus pneumoniae    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                                                                                  </a:t>
            </a:r>
            <a:endParaRPr lang="en-ID" sz="18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B0BCD9DF-C9AC-42FF-86BC-8C135F8F2E8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0680890"/>
              </p:ext>
            </p:extLst>
          </p:nvPr>
        </p:nvGraphicFramePr>
        <p:xfrm>
          <a:off x="435613" y="1572887"/>
          <a:ext cx="7093343" cy="4566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776934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CE30F9E-3C80-A3B3-301C-29F01AC3D983}"/>
              </a:ext>
            </a:extLst>
          </p:cNvPr>
          <p:cNvSpPr txBox="1"/>
          <p:nvPr/>
        </p:nvSpPr>
        <p:spPr>
          <a:xfrm>
            <a:off x="483920" y="539729"/>
            <a:ext cx="60979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. Vaccine Serotype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treptococcus pneumoniae</a:t>
            </a:r>
            <a:endParaRPr lang="en-ID" sz="18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D2BAB27-A7D2-4EF1-B8B1-BFD6DAE2AFE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872254184"/>
              </p:ext>
            </p:extLst>
          </p:nvPr>
        </p:nvGraphicFramePr>
        <p:xfrm>
          <a:off x="934694" y="1140030"/>
          <a:ext cx="7437409" cy="42109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7CBFC98-1D9B-19FD-1947-636CBDE9863D}"/>
              </a:ext>
            </a:extLst>
          </p:cNvPr>
          <p:cNvSpPr txBox="1"/>
          <p:nvPr/>
        </p:nvSpPr>
        <p:spPr>
          <a:xfrm>
            <a:off x="412173" y="5534495"/>
            <a:ext cx="11367654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he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total enrolled children overall and by study site in each age group used as the denominator in the figures. There were 1,822 children enrolled overall (&lt;1 year: 449; 1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–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 years: 762; 3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–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4 years: 611): 1,007 in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unungkidul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&lt;1 year: 243; 1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–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 years: 401; 3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–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4 years: 363) and 815 in Southwest Sumba (&lt;1 year: 206; 1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–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 years: 361; 3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–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4 years: 248).</a:t>
            </a:r>
            <a:endParaRPr lang="en-ID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ccin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erotypes were those included in PCV13 (1, 3, 4, 5, 6A, 6B, 7F, 9V, 14, 18C, 19A, 19F, and 23F).</a:t>
            </a:r>
            <a:endParaRPr lang="en-ID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289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6</Words>
  <Application>Microsoft Macintosh PowerPoint</Application>
  <PresentationFormat>Widescreen</PresentationFormat>
  <Paragraphs>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di Safari</dc:creator>
  <cp:lastModifiedBy>teti novianti</cp:lastModifiedBy>
  <cp:revision>4</cp:revision>
  <dcterms:created xsi:type="dcterms:W3CDTF">2023-07-09T16:20:04Z</dcterms:created>
  <dcterms:modified xsi:type="dcterms:W3CDTF">2024-01-01T12:26:37Z</dcterms:modified>
</cp:coreProperties>
</file>